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  <p:sldId id="263" r:id="rId4"/>
    <p:sldId id="257" r:id="rId5"/>
    <p:sldId id="261" r:id="rId6"/>
    <p:sldId id="258" r:id="rId7"/>
    <p:sldId id="25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5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B62CA-273D-45BB-9384-684491925B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735930D-E61A-4D6D-B00A-B1D83B89FA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BDC47C-C953-4EA1-A17E-04FEF3ABC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FD6E6B-84CA-4708-9E48-2D27BFBFE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0C6190-FE2F-4B3C-B159-CB921061E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725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CCC9F-877C-4E37-9ECB-BCED8DF1C7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A6A524-B6B7-47AA-B444-2EF631DA32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145C9-3236-499D-8732-4FD870DAF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6AA3FC-C0DD-4D59-B518-F9C78EC25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3C050B-C596-420B-8F3B-EBA5A4E56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037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833944-679B-41BF-9F4B-B79C12535A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D994CC1-2939-43FE-ABC1-7978C77AE5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A831C-7345-4E56-9340-6DA7063B9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C6B4EA-F07B-4855-8A71-BB00689BF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8E7C95-8D07-494C-8321-D34542432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705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E952C9-9822-4BD6-9184-5DBA10E69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2CA21D-0C56-4D4B-A4F1-A85E87A25E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C7460B-0A64-4BC8-BB5F-C246AD50E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9DD5D7-CBDA-4DAA-A7CE-A4864A36E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4CFA6E-2733-41A2-B944-B6D691CFC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245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0C4AF-E5F9-4C09-893F-66F89A510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0E3EA-1E28-4A06-A944-7F8F53B103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64C0AF-C443-4E87-8C45-C704A32D4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3F8F35-7DB1-405C-9C25-306B52C69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40775-5AF4-4B5F-849E-90F1E1B66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728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3FCF91-048F-47D4-BE52-4DAA8CCF34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2222AF-F657-4876-A711-20C63F90D1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F54FAB-EBF2-4ED9-AF1C-1C2F1664C3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E977C9-C6C3-415D-B3AC-EE46CCD5C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D0B4C2-58AB-40E1-8E63-139EA4F6D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5DC0C7-6B5E-4709-8841-2DBF63CA4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10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1FEF0-0954-47A8-A0A2-13C21571A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22186F-D657-4995-AB1A-0BCE42E2B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079963-632C-4249-A5D4-A6375C798B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629F921-8439-455E-9CB7-398FF4A2EA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9F7C4E-9456-49BF-8CB0-AA7BD2D6C6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46DF6F-D2AD-41CC-BD34-B4F4CE72F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14EE38-6FA5-46EF-9E03-FA826519E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F0E8C6-28E9-4149-9432-41BD2487C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72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74111-9DA1-4BFF-B986-17BC5FEFA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C5A80E-FA42-4E9D-9E09-EF1E2FE2B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ECE2CF-4992-4D81-AB9C-87B85A2D7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04A8C1-07F5-4A96-A720-9ADCAEEF0F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848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E778EB-7DBE-42C2-A541-8BE2DBA2E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279EF9-FD58-488B-B9EE-8996B70F8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A28DEBC-E689-4706-B35A-AB84D1EF1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384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AF7EC-DFBF-41BC-976E-95D2851D8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F3C7C8-33A1-4E56-9852-505E0F5F17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5C28FE-F205-4817-B6DB-36756AE02D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6FF005-CEB3-4F84-9AD0-A17E37D17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D41F11-5BD3-4785-904C-0937596B0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73D10E-4E85-45B5-9B14-016BCF7C6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535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DB82F8-DDE2-4CD9-BB42-58C849726D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9C80DA-48D0-4653-8E9D-9F6C971293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1C9A82-CE34-4C70-9583-7EB500EEF1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6288F-444A-4312-BACB-D257D08A6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4FB7A4-B307-45B6-9630-7FACF8AF0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398A5D-6DC9-4190-AA8B-13F2A016A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151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CC7465-E6F2-4C71-945B-EAEC1B70A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F1BC2B-13C1-438E-9B99-30243C7F46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F0E04B-0B19-4A87-81B6-46DD8098AE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49E588-40C1-4851-82DB-877AEE17F73E}" type="datetimeFigureOut">
              <a:rPr lang="en-US" smtClean="0"/>
              <a:t>1/2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8A8397-7D35-4FEF-96E3-DCA697FD29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46FBF0-CADA-4548-8811-DF105DE227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6B2C4-5844-4760-AB11-32770A9167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445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0678A3C-6A78-1F9C-0D0A-0E667239DA13}"/>
              </a:ext>
            </a:extLst>
          </p:cNvPr>
          <p:cNvGrpSpPr/>
          <p:nvPr/>
        </p:nvGrpSpPr>
        <p:grpSpPr>
          <a:xfrm>
            <a:off x="436107" y="877000"/>
            <a:ext cx="10973752" cy="3957446"/>
            <a:chOff x="233977" y="905876"/>
            <a:chExt cx="10973752" cy="3957446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FEC40BBD-1E05-A95E-43F1-C6EABFC63200}"/>
                </a:ext>
              </a:extLst>
            </p:cNvPr>
            <p:cNvGrpSpPr/>
            <p:nvPr/>
          </p:nvGrpSpPr>
          <p:grpSpPr>
            <a:xfrm>
              <a:off x="233977" y="1205404"/>
              <a:ext cx="10973752" cy="3657918"/>
              <a:chOff x="253227" y="1340158"/>
              <a:chExt cx="10973752" cy="3657918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F3C906A4-4A10-BF25-5FF8-32A8C2BCCC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53227" y="1340159"/>
                <a:ext cx="5486876" cy="3657917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B97FA9BB-1747-C20B-24F2-3846A738B6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40103" y="1340158"/>
                <a:ext cx="5486876" cy="3657917"/>
              </a:xfrm>
              <a:prstGeom prst="rect">
                <a:avLst/>
              </a:prstGeom>
            </p:spPr>
          </p:pic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CA68DB3-AD0A-325B-79C1-EC85AD99FB80}"/>
                </a:ext>
              </a:extLst>
            </p:cNvPr>
            <p:cNvSpPr txBox="1"/>
            <p:nvPr/>
          </p:nvSpPr>
          <p:spPr>
            <a:xfrm>
              <a:off x="500514" y="905876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900D290-CE5C-5236-ED3E-7A0322947F39}"/>
                </a:ext>
              </a:extLst>
            </p:cNvPr>
            <p:cNvSpPr txBox="1"/>
            <p:nvPr/>
          </p:nvSpPr>
          <p:spPr>
            <a:xfrm>
              <a:off x="5987390" y="909331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20CFC46E-56CF-7F2C-0B1B-52DFD4EC9CD9}"/>
              </a:ext>
            </a:extLst>
          </p:cNvPr>
          <p:cNvSpPr txBox="1"/>
          <p:nvPr/>
        </p:nvSpPr>
        <p:spPr>
          <a:xfrm>
            <a:off x="436107" y="5099765"/>
            <a:ext cx="109737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Overall survival of animals exposed to 5.8 or 6.5 Gy total-body irradiation over the 60-day observation period. Both dose groups exhibited early mortality, primarily within the first 20 days post-irradiation, after which survival stabilized. (B) Sex-stratified survival curves comparing males and females within each radiation dose group. While early mortality was observed across sexes, no pronounced long-term sex-specific differences in survival were evident by day 60. Survival is expressed as a percentage over time post-irradiation (days).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C738D7B-121D-4228-246C-2CA0CD189137}"/>
              </a:ext>
            </a:extLst>
          </p:cNvPr>
          <p:cNvSpPr/>
          <p:nvPr/>
        </p:nvSpPr>
        <p:spPr>
          <a:xfrm>
            <a:off x="436107" y="699796"/>
            <a:ext cx="11053249" cy="433873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7293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40DABEB8-8347-4C4E-A5AD-22ABF0473B66}"/>
              </a:ext>
            </a:extLst>
          </p:cNvPr>
          <p:cNvSpPr/>
          <p:nvPr/>
        </p:nvSpPr>
        <p:spPr>
          <a:xfrm>
            <a:off x="676656" y="42114"/>
            <a:ext cx="11018520" cy="61815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66887B-FBF9-4966-87ED-0AFF94FE9AC1}"/>
              </a:ext>
            </a:extLst>
          </p:cNvPr>
          <p:cNvSpPr txBox="1"/>
          <p:nvPr/>
        </p:nvSpPr>
        <p:spPr>
          <a:xfrm>
            <a:off x="676656" y="6241265"/>
            <a:ext cx="11018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Evaluation of vital signs and clinical parameters of animals exposed to 5.8 or 6.5 Gy total-body irradiation over the 60-day observation period. (B) Sex-stratified comparisons of males and females within each radiation dose group. The data for each time point is presented as the mean for each group.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19394093-58D8-7F69-67E0-8C8298813841}"/>
              </a:ext>
            </a:extLst>
          </p:cNvPr>
          <p:cNvGrpSpPr/>
          <p:nvPr/>
        </p:nvGrpSpPr>
        <p:grpSpPr>
          <a:xfrm>
            <a:off x="870776" y="119956"/>
            <a:ext cx="10454879" cy="6025896"/>
            <a:chOff x="870776" y="119956"/>
            <a:chExt cx="10454879" cy="6025896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A4794B99-745E-4A13-837A-3D7E6B477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6929" y="119956"/>
              <a:ext cx="4496341" cy="6025896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D949207-04F5-AF60-F2E8-BE10382E4D07}"/>
                </a:ext>
              </a:extLst>
            </p:cNvPr>
            <p:cNvSpPr txBox="1"/>
            <p:nvPr/>
          </p:nvSpPr>
          <p:spPr>
            <a:xfrm>
              <a:off x="870776" y="119956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84ABB2C-9399-69E7-8DD0-6606B886199C}"/>
                </a:ext>
              </a:extLst>
            </p:cNvPr>
            <p:cNvSpPr txBox="1"/>
            <p:nvPr/>
          </p:nvSpPr>
          <p:spPr>
            <a:xfrm>
              <a:off x="6228722" y="119956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9467525-2A7A-E211-22D0-FE3EE064C5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65450" y="119956"/>
              <a:ext cx="4560205" cy="602589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339097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757EC9F-AE61-CB1A-2055-0ACE0A9AF1CF}"/>
              </a:ext>
            </a:extLst>
          </p:cNvPr>
          <p:cNvSpPr/>
          <p:nvPr/>
        </p:nvSpPr>
        <p:spPr>
          <a:xfrm>
            <a:off x="2916937" y="45720"/>
            <a:ext cx="6217920" cy="62362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CD4DE0-2221-1D6C-BF9F-530949BBE001}"/>
              </a:ext>
            </a:extLst>
          </p:cNvPr>
          <p:cNvSpPr txBox="1"/>
          <p:nvPr/>
        </p:nvSpPr>
        <p:spPr>
          <a:xfrm>
            <a:off x="2770632" y="6314850"/>
            <a:ext cx="64830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-stratified complete blood count comparisons of males and females within each radiation dose group. The data for each time point is presented as the mean for each group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5C80C00-BADF-A871-52E4-9F14C815C5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1923" y="105155"/>
            <a:ext cx="4583401" cy="6126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81565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EEEDF94-B749-44DA-BAD4-06809A3B8D32}"/>
              </a:ext>
            </a:extLst>
          </p:cNvPr>
          <p:cNvSpPr/>
          <p:nvPr/>
        </p:nvSpPr>
        <p:spPr>
          <a:xfrm>
            <a:off x="173736" y="540051"/>
            <a:ext cx="11795759" cy="516362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CC07B2-5181-4D33-BC7E-89672A4CA231}"/>
              </a:ext>
            </a:extLst>
          </p:cNvPr>
          <p:cNvSpPr txBox="1"/>
          <p:nvPr/>
        </p:nvSpPr>
        <p:spPr>
          <a:xfrm>
            <a:off x="173737" y="5757022"/>
            <a:ext cx="117957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omplete blood counts of animals exposed to 5.8 or 6.5 Gy total-body irradiation over the 60-day observation period. (B) Sex-stratified comparisons of males and females within each radiation dose group. The data for each time point is presented as the mean for each group. A significant difference between the groups is denoted by the number of asterisks where *, **, and *** correspond to p &lt; 0.05, 0.01, and 0.001, respectively. This statistical approach was performed using a one-way ANOVA to compare the two radiation doses at each time point. 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DC636D76-5203-5443-D6C2-C8FA7A24E452}"/>
              </a:ext>
            </a:extLst>
          </p:cNvPr>
          <p:cNvGrpSpPr/>
          <p:nvPr/>
        </p:nvGrpSpPr>
        <p:grpSpPr>
          <a:xfrm>
            <a:off x="372606" y="716503"/>
            <a:ext cx="11417810" cy="4234162"/>
            <a:chOff x="372606" y="716503"/>
            <a:chExt cx="11417810" cy="423416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DBDA4C0-7244-48FE-BE21-BCB8E7B404D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2606" y="1293065"/>
              <a:ext cx="5515380" cy="36576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466F3A4-4CD6-82BC-EB83-1786D66B6D94}"/>
                </a:ext>
              </a:extLst>
            </p:cNvPr>
            <p:cNvSpPr txBox="1"/>
            <p:nvPr/>
          </p:nvSpPr>
          <p:spPr>
            <a:xfrm>
              <a:off x="372606" y="716503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EBC9826-82F9-AE17-98C3-FA767BB79C26}"/>
                </a:ext>
              </a:extLst>
            </p:cNvPr>
            <p:cNvSpPr txBox="1"/>
            <p:nvPr/>
          </p:nvSpPr>
          <p:spPr>
            <a:xfrm>
              <a:off x="6095874" y="716503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7B6D9CC-8719-C9DA-1566-37760F305E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04016" y="1293065"/>
              <a:ext cx="5486400" cy="3657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043265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7B4DF809-55FC-44FB-B8AB-F8E0A7AF20C9}"/>
              </a:ext>
            </a:extLst>
          </p:cNvPr>
          <p:cNvSpPr/>
          <p:nvPr/>
        </p:nvSpPr>
        <p:spPr>
          <a:xfrm>
            <a:off x="530352" y="42114"/>
            <a:ext cx="11237976" cy="61815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E163C75-3445-468E-B96B-3661AB214CB9}"/>
              </a:ext>
            </a:extLst>
          </p:cNvPr>
          <p:cNvSpPr txBox="1"/>
          <p:nvPr/>
        </p:nvSpPr>
        <p:spPr>
          <a:xfrm>
            <a:off x="0" y="6214365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iochemistry analysis of animals exposed to 5.8 or 6.5 Gy total-body irradiation over the 60-day observation period. (B) Sex-stratified comparisons of males and females within each radiation dose group. The data for each time point is presented as the mean for each group. A significant difference between the groups is denoted by the number of asterisks where *, **, and *** correspond to p &lt; 0.05, 0.01, and 0.001, respectively. This statistical approach was performed using a one-way ANOVA to compare the two radiation doses at each time point.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2601B6E2-935C-44E8-6940-C2B3361D3A38}"/>
              </a:ext>
            </a:extLst>
          </p:cNvPr>
          <p:cNvGrpSpPr/>
          <p:nvPr/>
        </p:nvGrpSpPr>
        <p:grpSpPr>
          <a:xfrm>
            <a:off x="882017" y="115292"/>
            <a:ext cx="10229046" cy="6035132"/>
            <a:chOff x="882017" y="115292"/>
            <a:chExt cx="10229046" cy="603513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49C0F42-1035-4CDF-92FE-8D2D02D4058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75865" y="124528"/>
              <a:ext cx="4523818" cy="602589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E45267B-DBEA-9CAE-9FD3-74353AF3B0E0}"/>
                </a:ext>
              </a:extLst>
            </p:cNvPr>
            <p:cNvSpPr txBox="1"/>
            <p:nvPr/>
          </p:nvSpPr>
          <p:spPr>
            <a:xfrm>
              <a:off x="882017" y="124528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A4CCAA8-C8AE-D41F-3CD3-69CAB0FA42AB}"/>
                </a:ext>
              </a:extLst>
            </p:cNvPr>
            <p:cNvSpPr txBox="1"/>
            <p:nvPr/>
          </p:nvSpPr>
          <p:spPr>
            <a:xfrm>
              <a:off x="6148635" y="118722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6D0261D-25C8-62CF-22A0-67C0FFB50A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93523" y="115292"/>
              <a:ext cx="4517540" cy="602589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647173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4279E17-D58D-44F5-A76A-49BE1E026316}"/>
              </a:ext>
            </a:extLst>
          </p:cNvPr>
          <p:cNvSpPr/>
          <p:nvPr/>
        </p:nvSpPr>
        <p:spPr>
          <a:xfrm>
            <a:off x="896112" y="30801"/>
            <a:ext cx="11045951" cy="61815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3A54DA-440E-44B5-B28B-4C8568E107A8}"/>
              </a:ext>
            </a:extLst>
          </p:cNvPr>
          <p:cNvSpPr txBox="1"/>
          <p:nvPr/>
        </p:nvSpPr>
        <p:spPr>
          <a:xfrm>
            <a:off x="0" y="6212382"/>
            <a:ext cx="12191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iochemistry analysis of animals exposed to 5.8 or 6.5 Gy total-body irradiation over the 60-day observation period. (B) Sex-stratified comparisons of males and females within each radiation dose group. The data for each time point is presented as the mean for each group. A significant difference between the groups is denoted by the number of asterisks where *, **, and *** correspond to p &lt; 0.05, 0.01, and 0.001, respectively. This statistical approach was performed using a one-way ANOVA to compare the two radiation doses at each time point. 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79212D84-C282-A69D-0D4E-9F12F96DF67F}"/>
              </a:ext>
            </a:extLst>
          </p:cNvPr>
          <p:cNvGrpSpPr/>
          <p:nvPr/>
        </p:nvGrpSpPr>
        <p:grpSpPr>
          <a:xfrm>
            <a:off x="1011954" y="99499"/>
            <a:ext cx="10302222" cy="6035040"/>
            <a:chOff x="1011954" y="99499"/>
            <a:chExt cx="10302222" cy="603504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180A6BF3-F0FC-421A-9E4F-7B1CD9EEB4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95711" y="108643"/>
              <a:ext cx="4592954" cy="602589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5F08F3B-2215-A8EC-44BB-7D98A4AC9BD9}"/>
                </a:ext>
              </a:extLst>
            </p:cNvPr>
            <p:cNvSpPr txBox="1"/>
            <p:nvPr/>
          </p:nvSpPr>
          <p:spPr>
            <a:xfrm>
              <a:off x="1011954" y="108643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B33BC73-44D8-EA31-DC29-3D8D4A2EE4C0}"/>
                </a:ext>
              </a:extLst>
            </p:cNvPr>
            <p:cNvSpPr txBox="1"/>
            <p:nvPr/>
          </p:nvSpPr>
          <p:spPr>
            <a:xfrm>
              <a:off x="6275679" y="108643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C23FCA9-0EBC-5D26-C17C-B5CD30E470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87209" y="99499"/>
              <a:ext cx="4526967" cy="602589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209963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66EB21F-37B0-4748-8291-CCD9CEBD7797}"/>
              </a:ext>
            </a:extLst>
          </p:cNvPr>
          <p:cNvSpPr/>
          <p:nvPr/>
        </p:nvSpPr>
        <p:spPr>
          <a:xfrm>
            <a:off x="548640" y="48907"/>
            <a:ext cx="11256263" cy="61815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CA7B609-2352-4528-B0F9-473829CD3A96}"/>
              </a:ext>
            </a:extLst>
          </p:cNvPr>
          <p:cNvSpPr txBox="1"/>
          <p:nvPr/>
        </p:nvSpPr>
        <p:spPr>
          <a:xfrm>
            <a:off x="0" y="6221435"/>
            <a:ext cx="12191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Biochemistry analysis of animals exposed to 5.8 or 6.5 Gy total-body irradiation over the 60-day observation period. (B) Sex-stratified comparisons of males and females within each radiation dose group. The data for each time point is presented as the mean for each group. A significant difference between the groups is denoted by the number of asterisks where *, **, and *** correspond to p &lt; 0.05, 0.01, and 0.001, respectively. This statistical approach was performed using a one-way ANOVA to compare the two radiation doses at each time point.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E4845DC1-B1E3-EDBD-78C2-6E393DE2EE0C}"/>
              </a:ext>
            </a:extLst>
          </p:cNvPr>
          <p:cNvGrpSpPr/>
          <p:nvPr/>
        </p:nvGrpSpPr>
        <p:grpSpPr>
          <a:xfrm>
            <a:off x="910529" y="67195"/>
            <a:ext cx="10344058" cy="6099212"/>
            <a:chOff x="910529" y="48907"/>
            <a:chExt cx="10344058" cy="609921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A6C4449-0F93-40FC-9A4F-483ACA2BB3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6194" y="122223"/>
              <a:ext cx="4600954" cy="6025896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0141605-5999-3312-D618-DB6BA2ADD4F4}"/>
                </a:ext>
              </a:extLst>
            </p:cNvPr>
            <p:cNvSpPr txBox="1"/>
            <p:nvPr/>
          </p:nvSpPr>
          <p:spPr>
            <a:xfrm>
              <a:off x="910529" y="48907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0D7CB6D-BAF5-D92D-611A-D57F78929640}"/>
                </a:ext>
              </a:extLst>
            </p:cNvPr>
            <p:cNvSpPr txBox="1"/>
            <p:nvPr/>
          </p:nvSpPr>
          <p:spPr>
            <a:xfrm>
              <a:off x="6229044" y="48907"/>
              <a:ext cx="4837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D8CE1B2-D74B-8C28-1AFC-CD923390F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21945" y="122223"/>
              <a:ext cx="4532642" cy="602589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7040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</TotalTime>
  <Words>625</Words>
  <Application>Microsoft Office PowerPoint</Application>
  <PresentationFormat>Widescreen</PresentationFormat>
  <Paragraphs>1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BRINK</dc:creator>
  <cp:lastModifiedBy>MATTHEW BRINK</cp:lastModifiedBy>
  <cp:revision>25</cp:revision>
  <dcterms:created xsi:type="dcterms:W3CDTF">2025-09-08T17:00:11Z</dcterms:created>
  <dcterms:modified xsi:type="dcterms:W3CDTF">2026-01-23T14:08:59Z</dcterms:modified>
</cp:coreProperties>
</file>